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AB0BE-E0D3-4497-A43C-1A61CD1783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18FEB-125D-48FC-9A10-A004F59D69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BA6DE-B6D5-4CEB-9757-0C9E7E08C0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96D91F-C0C4-400F-A82B-ABC40217A9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42EEDC-A74D-4B4A-B6C0-64767878FD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E3A07-3038-40F4-BB40-4BEE992315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B814C-ADF4-4073-8F63-3FF2433F6A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6309A-A2F0-43B9-B1F1-09DBC69820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18E15C-6B42-4EE0-9783-715A418922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0C9C9-70ED-4C63-AB69-351440B1FF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5B1A2-A699-44DA-8641-B97083033B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DB12BB-652F-44AD-BA34-F2D5FC3DBB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F4FF84-EAE0-432E-AD43-E1D125772C64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65000" y="5003640"/>
          <a:ext cx="5543640" cy="1828800"/>
        </p:xfrm>
        <a:graphic>
          <a:graphicData uri="http://schemas.openxmlformats.org/drawingml/2006/table">
            <a:tbl>
              <a:tblPr/>
              <a:tblGrid>
                <a:gridCol w="758880"/>
                <a:gridCol w="1976400"/>
                <a:gridCol w="2016360"/>
                <a:gridCol w="792000"/>
              </a:tblGrid>
              <a:tr h="152640">
                <a:tc gridSpan="4">
                  <a:txBody>
                    <a:bodyPr lIns="56520" rIns="5652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ble S2. qRT-PCR primer used in mouse experime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4560">
                <a:tc>
                  <a:txBody>
                    <a:bodyPr lIns="56520" rIns="565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rget genes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6520" rIns="565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 primer 5’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6520" rIns="565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 primer 5’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6520" rIns="565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oduct size (bp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71600">
                <a:tc>
                  <a:txBody>
                    <a:bodyPr lIns="56520" rIns="565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L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pbp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CAM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y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yn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s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m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act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6520" rIns="565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GCAGTCCACGAA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AGCCAGTTGTTG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CATGGCCATGGTCGAG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CGTGACAGGCATAC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AGCTGACACCCTCATTA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CTAAAGGCCCCATTGCT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TCGGACGACAGGA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GATGGAGGGGCCGGACTCA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6520" rIns="565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CAAGCAGGGTAGT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TTGCCTACCTTGAT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CAGGACAGGTCCAACA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GATCGTCTGGGTG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AGCCTTAGGAGGCTGAG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ATCCCCATCGTCTAC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GGGTCTCAGGTAAA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AAGACCTCTATGCCAACACA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6520" rIns="56520" tIns="0" bIns="0" anchor="t">
                      <a:noAutofit/>
                    </a:bodyPr>
                    <a:p>
                      <a:pPr marL="21420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21420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21420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21420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21420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21420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21420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21420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6520" marR="56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333360" y="1042920"/>
          <a:ext cx="6337440" cy="2590920"/>
        </p:xfrm>
        <a:graphic>
          <a:graphicData uri="http://schemas.openxmlformats.org/drawingml/2006/table">
            <a:tbl>
              <a:tblPr/>
              <a:tblGrid>
                <a:gridCol w="378000"/>
                <a:gridCol w="5959440"/>
              </a:tblGrid>
              <a:tr h="152640">
                <a:tc gridSpan="2">
                  <a:txBody>
                    <a:bodyPr lIns="49320" rIns="4932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ble S1. Oligonucleotide sequences for lentivirally expressing shR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9320" marR="49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38280">
                <a:tc>
                  <a:txBody>
                    <a:bodyPr lIns="49320" rIns="493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i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i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i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i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9320" marR="49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9320" rIns="49320" tIns="0" bIns="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nse-1 GATCCGCTCGCTGGTAGCTTACATCAATTCAAGAGATTGATGTAAGCTACCAGCGAGTTTTTTGC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-sense-1  GGCCGCAAAAAACTCGCTGGTAGCTTACATCAATCTCTTGAATTGATGTAAGCTACCAGCGAG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nse-2  GATCCGACCATCATGAATGGCCATCAATTCAAGAGATTGATGGCCATTCATGATGGTTTTTT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-sense-2 GGCCGCAAAAAAACCATCATGAATGGCCATCAATCTCTTGAATTGATGGCCATTCATGATGGT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nse-1 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 Unicode MS"/>
                        </a:rPr>
                        <a:t>GATCCGCTCCTTGGTTACAATCCTCAATTCAAGAGATTGAGGATTGTAACCAAGGAGTTTTT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-sense-1 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 Unicode MS"/>
                        </a:rPr>
                        <a:t>GGCCGCAAAAAACTCCTTGGTTACAATCCTCAATCTCTTGAATTGAGGATTGTAACCAAGGAG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nse-2 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 Unicode MS"/>
                        </a:rPr>
                        <a:t>GATCCGTCCGGTCAGTTCTATGACCAATTCAAGAGATTGGTCATAGAACTGACCGGATTTTT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-sense-2 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 Unicode MS"/>
                        </a:rPr>
                        <a:t>GGCCGCAAAAAATCCGGTCAGTTCTATGACCAATCTCTTGAATTGGTCATAGAACTGACCGGA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9320" marR="49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24T06:45:18Z</dcterms:created>
  <dc:creator>Windows 用户</dc:creator>
  <dc:description/>
  <dc:language>en-US</dc:language>
  <cp:lastModifiedBy>Windows 用户</cp:lastModifiedBy>
  <dcterms:modified xsi:type="dcterms:W3CDTF">2014-12-30T08:09:25Z</dcterms:modified>
  <cp:revision>1193</cp:revision>
  <dc:subject/>
  <dc:title>幻灯片 1</dc:title>
</cp:coreProperties>
</file>